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01"/>
  </p:normalViewPr>
  <p:slideViewPr>
    <p:cSldViewPr snapToGrid="0" snapToObjects="1">
      <p:cViewPr varScale="1">
        <p:scale>
          <a:sx n="73" d="100"/>
          <a:sy n="73" d="100"/>
        </p:scale>
        <p:origin x="370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C01CE1D3-4777-096E-235D-2689CED279E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2EBFA5DE-93DE-D2FC-39B3-0CD673E0DCB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256658AE-5F52-3CF5-D9BD-817230EFB6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C7F60-6B2A-F247-B733-90F9ACD26A63}" type="datetimeFigureOut">
              <a:rPr lang="sv-SE" smtClean="0"/>
              <a:t>2022-07-27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8A6B6E2D-9E20-537E-D5A6-2552E8EA4C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81C9BC75-0B3A-FC73-FB80-C8FD246FF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66D98-449D-3941-BAD6-18491EDFBEA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41517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2BA82040-101D-5391-6DC3-1AFC42F876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FD377005-BA82-E54A-4FD5-267E3D9DFB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7C03C7D9-51FA-4BE4-8234-C116E12264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C7F60-6B2A-F247-B733-90F9ACD26A63}" type="datetimeFigureOut">
              <a:rPr lang="sv-SE" smtClean="0"/>
              <a:t>2022-07-27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BA8E9F8C-328F-DE90-7B35-A25328003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CE10458B-D2F3-1A91-47C4-1A96F9BA7B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66D98-449D-3941-BAD6-18491EDFBEA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94409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9DD87C34-9269-F616-701D-657C1DDD82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2C641711-6EB7-4E44-F84A-5E2DE12F01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284CB6A4-48A3-CF27-21DE-D458369C5F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C7F60-6B2A-F247-B733-90F9ACD26A63}" type="datetimeFigureOut">
              <a:rPr lang="sv-SE" smtClean="0"/>
              <a:t>2022-07-27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1648F1FA-36FC-6651-827B-A749AC0B59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B9CA145E-D240-FA4D-511F-0FF9AD6871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66D98-449D-3941-BAD6-18491EDFBEA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7071096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4883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1DEB6636-58EC-A032-E529-8423DD2C42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C626876B-58EE-CBAE-4C62-2DA14F3FB03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589B89A2-3984-FAB5-5B32-AABAF9627A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C7F60-6B2A-F247-B733-90F9ACD26A63}" type="datetimeFigureOut">
              <a:rPr lang="sv-SE" smtClean="0"/>
              <a:t>2022-07-27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1E52D1FE-F2F3-C113-EF84-2B7B45470B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B19072CC-6F73-116E-2783-2116DA95D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66D98-449D-3941-BAD6-18491EDFBEA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065069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17596EC3-2084-44ED-24F4-D490441C2C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D6B88A0A-C6CB-88F6-CE17-8255A007AB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2F35A20E-02DB-5187-8273-E5E42A638C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C7F60-6B2A-F247-B733-90F9ACD26A63}" type="datetimeFigureOut">
              <a:rPr lang="sv-SE" smtClean="0"/>
              <a:t>2022-07-27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290CFE2E-B23F-9F84-C365-8B41B55E62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4B252346-33FD-8338-0650-41DF1E18E1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66D98-449D-3941-BAD6-18491EDFBEA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28319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6D56E788-9269-2E76-3ADC-E4A892E92D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7A9114D8-0667-16AF-F7B6-3E4BA3D387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EF263A1A-036F-0B25-6BD2-7884E58266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9CD443A6-63AF-2B76-82A0-70478112B7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C7F60-6B2A-F247-B733-90F9ACD26A63}" type="datetimeFigureOut">
              <a:rPr lang="sv-SE" smtClean="0"/>
              <a:t>2022-07-27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4988B782-F4A5-36A4-2F74-81AECAABA1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403ED891-1AAB-48DF-8C26-BB26489793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66D98-449D-3941-BAD6-18491EDFBEA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690714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EFE32436-10E4-99C7-0CCE-65C2117B74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DE85D3F1-2504-B806-4496-CF2758B287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158390C2-4D29-4121-725F-C68737D2F4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2B31D668-ACCE-3573-A070-8D96177D8B7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D73FD7F3-28EC-C434-93F3-817665168B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84292518-2833-D1C7-BA19-9B57BF1992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C7F60-6B2A-F247-B733-90F9ACD26A63}" type="datetimeFigureOut">
              <a:rPr lang="sv-SE" smtClean="0"/>
              <a:t>2022-07-27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CB76C1BE-A50E-E18C-43E9-6C0C4B5C91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AAC54BDF-B984-9DC8-6782-2694234E7F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66D98-449D-3941-BAD6-18491EDFBEA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77985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F2EAB4EE-EC5E-326C-4A81-2A1B048AE1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B747EF79-3365-0354-D594-5FF595F465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C7F60-6B2A-F247-B733-90F9ACD26A63}" type="datetimeFigureOut">
              <a:rPr lang="sv-SE" smtClean="0"/>
              <a:t>2022-07-27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13246E14-39AC-7B5F-19A4-95D1DD7A6A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B8E8D377-66CF-2201-8667-6BEA28780C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66D98-449D-3941-BAD6-18491EDFBEA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78514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060D892B-F4A6-313A-439D-7983F5B050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C7F60-6B2A-F247-B733-90F9ACD26A63}" type="datetimeFigureOut">
              <a:rPr lang="sv-SE" smtClean="0"/>
              <a:t>2022-07-27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42B7CA3E-6965-C163-FA44-3A34F7DFF0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835BD1DD-356B-51EE-C2AD-D00BBD3BA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66D98-449D-3941-BAD6-18491EDFBEA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104041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AFD8E93D-A08F-E606-E436-8C9DAA7E6A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08DA023A-3BCF-5930-90ED-82658889CF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5714BEE7-C3A8-981D-4444-F26CC08ED8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602B5090-8203-95A8-0CA3-AD34593F10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C7F60-6B2A-F247-B733-90F9ACD26A63}" type="datetimeFigureOut">
              <a:rPr lang="sv-SE" smtClean="0"/>
              <a:t>2022-07-27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F7801FBD-C5E7-8B81-6F24-E8EFE286D7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9CAAB4AB-1019-424C-DCFD-4E86BE9B6C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66D98-449D-3941-BAD6-18491EDFBEA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068619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A0027F09-9F61-8151-1681-9DF06F5387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A2C82737-567E-A3E9-119D-46B7AE6107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B4A212CE-1484-C5E2-F1B6-E861B46C6E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7DEDF17D-5B93-8185-3E6E-F1779D1EB7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C7F60-6B2A-F247-B733-90F9ACD26A63}" type="datetimeFigureOut">
              <a:rPr lang="sv-SE" smtClean="0"/>
              <a:t>2022-07-27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696A4546-7D3C-1C97-D5F5-5B690D21FA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57BF5AC8-5BF8-F16B-03D6-377D55C120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66D98-449D-3941-BAD6-18491EDFBEA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805532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373859B4-2384-3C22-E91C-18F6948C81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83E56A52-EB45-E36F-CF77-A9198A19AA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50E3FAAF-4D5E-A460-38DA-0F6B597946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1C7F60-6B2A-F247-B733-90F9ACD26A63}" type="datetimeFigureOut">
              <a:rPr lang="sv-SE" smtClean="0"/>
              <a:t>2022-07-27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B77A0B00-84FD-2B92-A45A-11469D9565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B2966BC8-A38E-BD3B-1B2C-D184FDB3F4B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866D98-449D-3941-BAD6-18491EDFBEA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033934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400" b="1" dirty="0">
                <a:solidFill>
                  <a:schemeClr val="bg1"/>
                </a:solidFill>
              </a:rPr>
              <a:t>Kidney outcomes in early adolescence following perinatal asphyxia </a:t>
            </a:r>
          </a:p>
          <a:p>
            <a:pPr marL="216000" algn="l"/>
            <a:r>
              <a:rPr lang="en-GB" sz="2400" b="1" dirty="0">
                <a:solidFill>
                  <a:schemeClr val="bg1"/>
                </a:solidFill>
              </a:rPr>
              <a:t>and hypothermia-treated hypoxic-ischaemic encephalopathy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17185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Survivors of perinatal asphyxia and hypothermia-treated HIE may have signs of CKD in early adolescence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Robertsson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Grossmann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667763"/>
            <a:ext cx="7141846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Kidney abnormalities were rare in early adolescence following hypothermia-treated HIE, regardless of presence or absence of a history of neonatal AKI. More studies are needed to elucidate long-term kidney consequences in this patient population.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C5396803-47C1-76A6-D518-42A72D1465CD}"/>
              </a:ext>
            </a:extLst>
          </p:cNvPr>
          <p:cNvSpPr/>
          <p:nvPr/>
        </p:nvSpPr>
        <p:spPr>
          <a:xfrm>
            <a:off x="802516" y="302113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0" name="Freeform: Shape 46">
            <a:extLst>
              <a:ext uri="{FF2B5EF4-FFF2-40B4-BE49-F238E27FC236}">
                <a16:creationId xmlns:a16="http://schemas.microsoft.com/office/drawing/2014/main" id="{3186C1D3-7665-2EC1-0F56-A2F0A493B4FD}"/>
              </a:ext>
            </a:extLst>
          </p:cNvPr>
          <p:cNvSpPr/>
          <p:nvPr/>
        </p:nvSpPr>
        <p:spPr>
          <a:xfrm>
            <a:off x="391382" y="302113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3" name="Rectangle 19">
            <a:extLst>
              <a:ext uri="{FF2B5EF4-FFF2-40B4-BE49-F238E27FC236}">
                <a16:creationId xmlns:a16="http://schemas.microsoft.com/office/drawing/2014/main" id="{96F5A078-17CA-DDA0-88A7-FF27F3B7483D}"/>
              </a:ext>
            </a:extLst>
          </p:cNvPr>
          <p:cNvSpPr/>
          <p:nvPr/>
        </p:nvSpPr>
        <p:spPr>
          <a:xfrm>
            <a:off x="6821459" y="1827383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GFR</a:t>
            </a:r>
          </a:p>
        </p:txBody>
      </p:sp>
      <p:sp>
        <p:nvSpPr>
          <p:cNvPr id="14" name="Rectangle 19">
            <a:extLst>
              <a:ext uri="{FF2B5EF4-FFF2-40B4-BE49-F238E27FC236}">
                <a16:creationId xmlns:a16="http://schemas.microsoft.com/office/drawing/2014/main" id="{402AD939-3B60-8B2D-2DA3-BAA6081528B6}"/>
              </a:ext>
            </a:extLst>
          </p:cNvPr>
          <p:cNvSpPr/>
          <p:nvPr/>
        </p:nvSpPr>
        <p:spPr>
          <a:xfrm>
            <a:off x="6812247" y="2549020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Albuminuria</a:t>
            </a:r>
          </a:p>
        </p:txBody>
      </p:sp>
      <p:sp>
        <p:nvSpPr>
          <p:cNvPr id="15" name="Rectangle 19">
            <a:extLst>
              <a:ext uri="{FF2B5EF4-FFF2-40B4-BE49-F238E27FC236}">
                <a16:creationId xmlns:a16="http://schemas.microsoft.com/office/drawing/2014/main" id="{5F327771-9015-ED3E-5DD5-22DAF12A1429}"/>
              </a:ext>
            </a:extLst>
          </p:cNvPr>
          <p:cNvSpPr/>
          <p:nvPr/>
        </p:nvSpPr>
        <p:spPr>
          <a:xfrm>
            <a:off x="6802022" y="3303395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Blood pressure</a:t>
            </a:r>
          </a:p>
        </p:txBody>
      </p:sp>
      <p:sp>
        <p:nvSpPr>
          <p:cNvPr id="16" name="Rectangle 19">
            <a:extLst>
              <a:ext uri="{FF2B5EF4-FFF2-40B4-BE49-F238E27FC236}">
                <a16:creationId xmlns:a16="http://schemas.microsoft.com/office/drawing/2014/main" id="{A2C762A7-0FDB-34DB-4CE9-CE0E7F58E4A5}"/>
              </a:ext>
            </a:extLst>
          </p:cNvPr>
          <p:cNvSpPr/>
          <p:nvPr/>
        </p:nvSpPr>
        <p:spPr>
          <a:xfrm>
            <a:off x="6812247" y="4055215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Kidney volume</a:t>
            </a:r>
          </a:p>
        </p:txBody>
      </p:sp>
      <p:sp>
        <p:nvSpPr>
          <p:cNvPr id="18" name="Rectangle 19">
            <a:extLst>
              <a:ext uri="{FF2B5EF4-FFF2-40B4-BE49-F238E27FC236}">
                <a16:creationId xmlns:a16="http://schemas.microsoft.com/office/drawing/2014/main" id="{11970311-F405-C0FA-DF33-44CAE040344E}"/>
              </a:ext>
            </a:extLst>
          </p:cNvPr>
          <p:cNvSpPr/>
          <p:nvPr/>
        </p:nvSpPr>
        <p:spPr>
          <a:xfrm>
            <a:off x="6802023" y="4770710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Plasma FGF 23</a:t>
            </a:r>
          </a:p>
        </p:txBody>
      </p:sp>
      <p:sp>
        <p:nvSpPr>
          <p:cNvPr id="29" name="TextBox 21">
            <a:extLst>
              <a:ext uri="{FF2B5EF4-FFF2-40B4-BE49-F238E27FC236}">
                <a16:creationId xmlns:a16="http://schemas.microsoft.com/office/drawing/2014/main" id="{4FED77C0-3800-2DEA-254D-34AAFFE59BA7}"/>
              </a:ext>
            </a:extLst>
          </p:cNvPr>
          <p:cNvSpPr txBox="1"/>
          <p:nvPr/>
        </p:nvSpPr>
        <p:spPr>
          <a:xfrm>
            <a:off x="4332523" y="3391006"/>
            <a:ext cx="24694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>
                <a:solidFill>
                  <a:srgbClr val="00437A"/>
                </a:solidFill>
              </a:rPr>
              <a:t>10 – 12 years</a:t>
            </a:r>
          </a:p>
        </p:txBody>
      </p:sp>
      <p:sp>
        <p:nvSpPr>
          <p:cNvPr id="36" name="Rectangle 55">
            <a:extLst>
              <a:ext uri="{FF2B5EF4-FFF2-40B4-BE49-F238E27FC236}">
                <a16:creationId xmlns:a16="http://schemas.microsoft.com/office/drawing/2014/main" id="{350E0D05-2BC5-A1FB-9AE8-01E0EB7D65A8}"/>
              </a:ext>
            </a:extLst>
          </p:cNvPr>
          <p:cNvSpPr/>
          <p:nvPr/>
        </p:nvSpPr>
        <p:spPr>
          <a:xfrm>
            <a:off x="9122015" y="3752680"/>
            <a:ext cx="2915973" cy="1375778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indent="-285750">
              <a:buFont typeface="Wingdings" pitchFamily="2" charset="2"/>
              <a:buChar char="§"/>
            </a:pPr>
            <a:r>
              <a:rPr lang="en-GB" dirty="0"/>
              <a:t>1 child with mildly decreased GFR</a:t>
            </a:r>
          </a:p>
          <a:p>
            <a:pPr marL="285750" indent="-285750">
              <a:buFont typeface="Wingdings" pitchFamily="2" charset="2"/>
              <a:buChar char="§"/>
            </a:pPr>
            <a:r>
              <a:rPr lang="en-GB" dirty="0"/>
              <a:t>1 child with KDIGO category A2 albuminuria</a:t>
            </a:r>
          </a:p>
        </p:txBody>
      </p:sp>
      <p:sp>
        <p:nvSpPr>
          <p:cNvPr id="37" name="Rectangle 6">
            <a:extLst>
              <a:ext uri="{FF2B5EF4-FFF2-40B4-BE49-F238E27FC236}">
                <a16:creationId xmlns:a16="http://schemas.microsoft.com/office/drawing/2014/main" id="{70AC7DCE-BD6D-E578-2F79-3A4641E51013}"/>
              </a:ext>
            </a:extLst>
          </p:cNvPr>
          <p:cNvSpPr/>
          <p:nvPr/>
        </p:nvSpPr>
        <p:spPr>
          <a:xfrm>
            <a:off x="9122015" y="2145395"/>
            <a:ext cx="2915973" cy="1375778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indent="-285750">
              <a:buFont typeface="Wingdings" pitchFamily="2" charset="2"/>
              <a:buChar char="§"/>
            </a:pPr>
            <a:r>
              <a:rPr lang="en-GB" dirty="0"/>
              <a:t>1 child with high normal blood pressure</a:t>
            </a:r>
          </a:p>
        </p:txBody>
      </p:sp>
      <p:cxnSp>
        <p:nvCxnSpPr>
          <p:cNvPr id="38" name="Straight Arrow Connector 13">
            <a:extLst>
              <a:ext uri="{FF2B5EF4-FFF2-40B4-BE49-F238E27FC236}">
                <a16:creationId xmlns:a16="http://schemas.microsoft.com/office/drawing/2014/main" id="{C941D4F8-272F-9C8A-80A3-D64491547698}"/>
              </a:ext>
            </a:extLst>
          </p:cNvPr>
          <p:cNvCxnSpPr>
            <a:cxnSpLocks/>
          </p:cNvCxnSpPr>
          <p:nvPr/>
        </p:nvCxnSpPr>
        <p:spPr>
          <a:xfrm>
            <a:off x="8656885" y="3637035"/>
            <a:ext cx="346696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Rectangle 6">
            <a:extLst>
              <a:ext uri="{FF2B5EF4-FFF2-40B4-BE49-F238E27FC236}">
                <a16:creationId xmlns:a16="http://schemas.microsoft.com/office/drawing/2014/main" id="{550CE549-53DC-D5C3-8521-53CF270920B2}"/>
              </a:ext>
            </a:extLst>
          </p:cNvPr>
          <p:cNvSpPr/>
          <p:nvPr/>
        </p:nvSpPr>
        <p:spPr>
          <a:xfrm>
            <a:off x="1685690" y="2923498"/>
            <a:ext cx="172838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No neonatal AKI (n=27)</a:t>
            </a:r>
          </a:p>
        </p:txBody>
      </p:sp>
      <p:sp>
        <p:nvSpPr>
          <p:cNvPr id="40" name="Rectangle 55">
            <a:extLst>
              <a:ext uri="{FF2B5EF4-FFF2-40B4-BE49-F238E27FC236}">
                <a16:creationId xmlns:a16="http://schemas.microsoft.com/office/drawing/2014/main" id="{5720DD63-AC2A-A691-B7D5-65B47EB6E189}"/>
              </a:ext>
            </a:extLst>
          </p:cNvPr>
          <p:cNvSpPr/>
          <p:nvPr/>
        </p:nvSpPr>
        <p:spPr>
          <a:xfrm>
            <a:off x="1667425" y="3671585"/>
            <a:ext cx="1746650" cy="660439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Neonatal AKI (n=20)</a:t>
            </a:r>
          </a:p>
        </p:txBody>
      </p:sp>
      <p:cxnSp>
        <p:nvCxnSpPr>
          <p:cNvPr id="41" name="Straight Arrow Connector 13">
            <a:extLst>
              <a:ext uri="{FF2B5EF4-FFF2-40B4-BE49-F238E27FC236}">
                <a16:creationId xmlns:a16="http://schemas.microsoft.com/office/drawing/2014/main" id="{A97F0E2F-AEFD-53F0-0743-84F1D747B6F0}"/>
              </a:ext>
            </a:extLst>
          </p:cNvPr>
          <p:cNvCxnSpPr>
            <a:cxnSpLocks/>
          </p:cNvCxnSpPr>
          <p:nvPr/>
        </p:nvCxnSpPr>
        <p:spPr>
          <a:xfrm>
            <a:off x="3607380" y="3610506"/>
            <a:ext cx="941282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Vänster klammerparentes 2">
            <a:extLst>
              <a:ext uri="{FF2B5EF4-FFF2-40B4-BE49-F238E27FC236}">
                <a16:creationId xmlns:a16="http://schemas.microsoft.com/office/drawing/2014/main" id="{B64F4F2C-B685-43DB-D29B-4961E2B3F4C8}"/>
              </a:ext>
            </a:extLst>
          </p:cNvPr>
          <p:cNvSpPr/>
          <p:nvPr/>
        </p:nvSpPr>
        <p:spPr>
          <a:xfrm>
            <a:off x="6628672" y="2163446"/>
            <a:ext cx="173350" cy="2921863"/>
          </a:xfrm>
          <a:prstGeom prst="leftBrace">
            <a:avLst/>
          </a:prstGeom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33" name="TextBox 21">
            <a:extLst>
              <a:ext uri="{FF2B5EF4-FFF2-40B4-BE49-F238E27FC236}">
                <a16:creationId xmlns:a16="http://schemas.microsoft.com/office/drawing/2014/main" id="{A75B208B-6F96-43EE-023C-1B1B55ED44D2}"/>
              </a:ext>
            </a:extLst>
          </p:cNvPr>
          <p:cNvSpPr txBox="1"/>
          <p:nvPr/>
        </p:nvSpPr>
        <p:spPr>
          <a:xfrm>
            <a:off x="154012" y="2088152"/>
            <a:ext cx="34533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00437A"/>
                </a:solidFill>
              </a:rPr>
              <a:t>Perinatal asphyxia and hypothermia-treated HIE</a:t>
            </a:r>
          </a:p>
        </p:txBody>
      </p:sp>
      <p:sp>
        <p:nvSpPr>
          <p:cNvPr id="34" name="TextBox 21">
            <a:extLst>
              <a:ext uri="{FF2B5EF4-FFF2-40B4-BE49-F238E27FC236}">
                <a16:creationId xmlns:a16="http://schemas.microsoft.com/office/drawing/2014/main" id="{68EE681E-1724-50DB-30E7-8135DF67C11B}"/>
              </a:ext>
            </a:extLst>
          </p:cNvPr>
          <p:cNvSpPr txBox="1"/>
          <p:nvPr/>
        </p:nvSpPr>
        <p:spPr>
          <a:xfrm>
            <a:off x="154012" y="4557808"/>
            <a:ext cx="34533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00437A"/>
                </a:solidFill>
              </a:rPr>
              <a:t>Prospective population-based study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7</TotalTime>
  <Words>134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-tema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Katarina Robertsson Grossmann</dc:creator>
  <cp:lastModifiedBy>Laycock, Joseph</cp:lastModifiedBy>
  <cp:revision>6</cp:revision>
  <dcterms:created xsi:type="dcterms:W3CDTF">2022-07-15T16:22:04Z</dcterms:created>
  <dcterms:modified xsi:type="dcterms:W3CDTF">2022-07-27T10:53:55Z</dcterms:modified>
</cp:coreProperties>
</file>